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313863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07B79E-C249-4512-9CBF-491736724DA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39360" y="365040"/>
            <a:ext cx="80326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39360" y="1825200"/>
            <a:ext cx="80326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39360" y="4098240"/>
            <a:ext cx="80326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04D79C-C99D-446A-A587-B061EBB1AEF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39360" y="365040"/>
            <a:ext cx="80326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39360" y="1825200"/>
            <a:ext cx="39196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755240" y="1825200"/>
            <a:ext cx="39196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39360" y="4098240"/>
            <a:ext cx="39196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755240" y="4098240"/>
            <a:ext cx="39196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6DA7D7-C8E1-4096-B49F-18F5064729D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39360" y="365040"/>
            <a:ext cx="80326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39360" y="1825200"/>
            <a:ext cx="25862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55200" y="1825200"/>
            <a:ext cx="25862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71400" y="1825200"/>
            <a:ext cx="25862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39360" y="4098240"/>
            <a:ext cx="25862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55200" y="4098240"/>
            <a:ext cx="25862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71400" y="4098240"/>
            <a:ext cx="25862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1A998D-AE51-41FC-91AC-675183BD8F3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39360" y="365040"/>
            <a:ext cx="80326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39360" y="1825200"/>
            <a:ext cx="80326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8EF757-539D-4D78-9C3C-08A834A842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39360" y="365040"/>
            <a:ext cx="80326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39360" y="1825200"/>
            <a:ext cx="80326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38B3A1-5A07-4EBE-9AD6-2F652778A2E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39360" y="365040"/>
            <a:ext cx="80326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39360" y="1825200"/>
            <a:ext cx="39196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755240" y="1825200"/>
            <a:ext cx="39196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259E77-28FE-4940-893E-CE6A0E1706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39360" y="365040"/>
            <a:ext cx="80326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8DCC58-2E4D-4E7D-88EE-91CB80995F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39360" y="365040"/>
            <a:ext cx="80326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EC222B-EAEE-4DFB-8839-3468A46618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39360" y="365040"/>
            <a:ext cx="80326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39360" y="1825200"/>
            <a:ext cx="39196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755240" y="1825200"/>
            <a:ext cx="39196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39360" y="4098240"/>
            <a:ext cx="39196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B75B7F-A515-4E39-8CF7-2CEFAB185EA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39360" y="365040"/>
            <a:ext cx="80326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39360" y="1825200"/>
            <a:ext cx="39196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755240" y="1825200"/>
            <a:ext cx="39196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755240" y="4098240"/>
            <a:ext cx="39196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1E5C72-82F9-46BF-B13B-420F4251AB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39360" y="365040"/>
            <a:ext cx="80326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39360" y="1825200"/>
            <a:ext cx="39196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755240" y="1825200"/>
            <a:ext cx="39196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39360" y="4098240"/>
            <a:ext cx="803268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B44597-2050-4C92-A279-4DCA854757A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39360" y="365040"/>
            <a:ext cx="803268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39360" y="1825200"/>
            <a:ext cx="803268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39360" y="6356520"/>
            <a:ext cx="20955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84120" y="6356520"/>
            <a:ext cx="31431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76480" y="6356520"/>
            <a:ext cx="20955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5F815FE-A260-4588-8B4F-3D6820FF9E94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3"/>
          <p:cNvGrpSpPr/>
          <p:nvPr/>
        </p:nvGrpSpPr>
        <p:grpSpPr>
          <a:xfrm>
            <a:off x="800280" y="479520"/>
            <a:ext cx="6607080" cy="2878200"/>
            <a:chOff x="800280" y="479520"/>
            <a:chExt cx="6607080" cy="2878200"/>
          </a:xfrm>
        </p:grpSpPr>
        <p:pic>
          <p:nvPicPr>
            <p:cNvPr id="42" name="Picture 4" descr=""/>
            <p:cNvPicPr/>
            <p:nvPr/>
          </p:nvPicPr>
          <p:blipFill>
            <a:blip r:embed="rId1"/>
            <a:stretch/>
          </p:blipFill>
          <p:spPr>
            <a:xfrm>
              <a:off x="4928760" y="2418480"/>
              <a:ext cx="861840" cy="939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Picture 5" descr=""/>
            <p:cNvPicPr/>
            <p:nvPr/>
          </p:nvPicPr>
          <p:blipFill>
            <a:blip r:embed="rId2"/>
            <a:stretch/>
          </p:blipFill>
          <p:spPr>
            <a:xfrm>
              <a:off x="3563280" y="1910160"/>
              <a:ext cx="942840" cy="6318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Straight Connector 6"/>
            <p:cNvSpPr/>
            <p:nvPr/>
          </p:nvSpPr>
          <p:spPr>
            <a:xfrm flipV="1">
              <a:off x="1074600" y="933480"/>
              <a:ext cx="2452680" cy="79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Rectangle 7"/>
            <p:cNvSpPr/>
            <p:nvPr/>
          </p:nvSpPr>
          <p:spPr>
            <a:xfrm>
              <a:off x="1181160" y="760320"/>
              <a:ext cx="307800" cy="380880"/>
            </a:xfrm>
            <a:prstGeom prst="rect">
              <a:avLst/>
            </a:prstGeom>
            <a:solidFill>
              <a:srgbClr val="ff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Box 8"/>
            <p:cNvSpPr/>
            <p:nvPr/>
          </p:nvSpPr>
          <p:spPr>
            <a:xfrm>
              <a:off x="1135800" y="798120"/>
              <a:ext cx="461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ffffff"/>
                  </a:solidFill>
                  <a:latin typeface="Calibri"/>
                </a:rPr>
                <a:t>hU6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Rectangle 9"/>
            <p:cNvSpPr/>
            <p:nvPr/>
          </p:nvSpPr>
          <p:spPr>
            <a:xfrm>
              <a:off x="2184480" y="760320"/>
              <a:ext cx="376200" cy="380880"/>
            </a:xfrm>
            <a:prstGeom prst="rect">
              <a:avLst/>
            </a:prstGeom>
            <a:solidFill>
              <a:srgbClr val="ff000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TextBox 10"/>
            <p:cNvSpPr/>
            <p:nvPr/>
          </p:nvSpPr>
          <p:spPr>
            <a:xfrm>
              <a:off x="2148120" y="799200"/>
              <a:ext cx="540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ffffff"/>
                  </a:solidFill>
                  <a:latin typeface="Calibri"/>
                </a:rPr>
                <a:t>EGFP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Rectangle 11"/>
            <p:cNvSpPr/>
            <p:nvPr/>
          </p:nvSpPr>
          <p:spPr>
            <a:xfrm>
              <a:off x="1557360" y="755640"/>
              <a:ext cx="560160" cy="385560"/>
            </a:xfrm>
            <a:prstGeom prst="rect">
              <a:avLst/>
            </a:prstGeom>
            <a:solidFill>
              <a:srgbClr val="00b0f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12"/>
            <p:cNvSpPr/>
            <p:nvPr/>
          </p:nvSpPr>
          <p:spPr>
            <a:xfrm>
              <a:off x="1518840" y="794880"/>
              <a:ext cx="7398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ffffff"/>
                  </a:solidFill>
                  <a:latin typeface="Calibri"/>
                </a:rPr>
                <a:t>sgBRCA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51" name="Elbow Connector 13"/>
            <p:cNvCxnSpPr/>
            <p:nvPr/>
          </p:nvCxnSpPr>
          <p:spPr>
            <a:xfrm flipH="1" flipV="1" rot="5400000">
              <a:off x="1436400" y="485280"/>
              <a:ext cx="164160" cy="367200"/>
            </a:xfrm>
            <a:prstGeom prst="bentConnector2">
              <a:avLst/>
            </a:prstGeom>
            <a:ln w="7632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52" name="Elbow Connector 14"/>
            <p:cNvCxnSpPr/>
            <p:nvPr/>
          </p:nvCxnSpPr>
          <p:spPr>
            <a:xfrm flipH="1" flipV="1" rot="5400000">
              <a:off x="2454840" y="490680"/>
              <a:ext cx="162360" cy="367200"/>
            </a:xfrm>
            <a:prstGeom prst="bentConnector2">
              <a:avLst/>
            </a:prstGeom>
            <a:ln w="7632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53" name="Rectangle 15"/>
            <p:cNvSpPr/>
            <p:nvPr/>
          </p:nvSpPr>
          <p:spPr>
            <a:xfrm>
              <a:off x="2611440" y="755640"/>
              <a:ext cx="509400" cy="380880"/>
            </a:xfrm>
            <a:prstGeom prst="rect">
              <a:avLst/>
            </a:prstGeom>
            <a:solidFill>
              <a:srgbClr val="92d050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16"/>
            <p:cNvSpPr/>
            <p:nvPr/>
          </p:nvSpPr>
          <p:spPr>
            <a:xfrm>
              <a:off x="2608200" y="805680"/>
              <a:ext cx="509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ffffff"/>
                  </a:solidFill>
                  <a:latin typeface="Calibri"/>
                </a:rPr>
                <a:t>Cas9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Rectangle 17"/>
            <p:cNvSpPr/>
            <p:nvPr/>
          </p:nvSpPr>
          <p:spPr>
            <a:xfrm>
              <a:off x="3075120" y="755640"/>
              <a:ext cx="376200" cy="380880"/>
            </a:xfrm>
            <a:prstGeom prst="rect">
              <a:avLst/>
            </a:prstGeom>
            <a:solidFill>
              <a:srgbClr val="ffd966"/>
            </a:solidFill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18"/>
            <p:cNvSpPr/>
            <p:nvPr/>
          </p:nvSpPr>
          <p:spPr>
            <a:xfrm>
              <a:off x="3085920" y="794880"/>
              <a:ext cx="374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ffffff"/>
                  </a:solidFill>
                  <a:latin typeface="Calibri"/>
                </a:rPr>
                <a:t>2A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Straight Connector 19"/>
            <p:cNvSpPr/>
            <p:nvPr/>
          </p:nvSpPr>
          <p:spPr>
            <a:xfrm flipH="1">
              <a:off x="3484800" y="795240"/>
              <a:ext cx="101520" cy="2761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Straight Connector 20"/>
            <p:cNvSpPr/>
            <p:nvPr/>
          </p:nvSpPr>
          <p:spPr>
            <a:xfrm flipH="1">
              <a:off x="3538800" y="803160"/>
              <a:ext cx="102960" cy="2761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Straight Connector 21"/>
            <p:cNvSpPr/>
            <p:nvPr/>
          </p:nvSpPr>
          <p:spPr>
            <a:xfrm flipH="1">
              <a:off x="960480" y="807840"/>
              <a:ext cx="101520" cy="2761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Straight Connector 22"/>
            <p:cNvSpPr/>
            <p:nvPr/>
          </p:nvSpPr>
          <p:spPr>
            <a:xfrm flipH="1">
              <a:off x="1014480" y="812880"/>
              <a:ext cx="102960" cy="27612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Straight Connector 23"/>
            <p:cNvSpPr/>
            <p:nvPr/>
          </p:nvSpPr>
          <p:spPr>
            <a:xfrm>
              <a:off x="3592800" y="941400"/>
              <a:ext cx="2109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Straight Connector 24"/>
            <p:cNvSpPr/>
            <p:nvPr/>
          </p:nvSpPr>
          <p:spPr>
            <a:xfrm>
              <a:off x="800280" y="933480"/>
              <a:ext cx="2109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25"/>
            <p:cNvSpPr/>
            <p:nvPr/>
          </p:nvSpPr>
          <p:spPr>
            <a:xfrm>
              <a:off x="3441240" y="479520"/>
              <a:ext cx="998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Calibri"/>
                </a:rPr>
                <a:t>pX-458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Straight Connector 26"/>
            <p:cNvSpPr/>
            <p:nvPr/>
          </p:nvSpPr>
          <p:spPr>
            <a:xfrm flipH="1">
              <a:off x="2719080" y="941400"/>
              <a:ext cx="1083960" cy="121428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Straight Connector 27"/>
            <p:cNvSpPr/>
            <p:nvPr/>
          </p:nvSpPr>
          <p:spPr>
            <a:xfrm>
              <a:off x="812880" y="947880"/>
              <a:ext cx="1158840" cy="1225440"/>
            </a:xfrm>
            <a:prstGeom prst="line">
              <a:avLst/>
            </a:prstGeom>
            <a:ln w="6480">
              <a:solidFill>
                <a:srgbClr val="5b9bd5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Box 28"/>
            <p:cNvSpPr/>
            <p:nvPr/>
          </p:nvSpPr>
          <p:spPr>
            <a:xfrm>
              <a:off x="1597320" y="2172960"/>
              <a:ext cx="1478160" cy="6415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Lipofectamine Transfection of human fibroblasts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67" name="Straight Arrow Connector 29"/>
            <p:cNvCxnSpPr/>
            <p:nvPr/>
          </p:nvCxnSpPr>
          <p:spPr>
            <a:xfrm>
              <a:off x="5791320" y="2767320"/>
              <a:ext cx="475200" cy="2160"/>
            </a:xfrm>
            <a:prstGeom prst="straightConnector1">
              <a:avLst/>
            </a:prstGeom>
            <a:ln w="5724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8" name="Straight Arrow Connector 30"/>
            <p:cNvCxnSpPr/>
            <p:nvPr/>
          </p:nvCxnSpPr>
          <p:spPr>
            <a:xfrm>
              <a:off x="4473720" y="2257560"/>
              <a:ext cx="501840" cy="405360"/>
            </a:xfrm>
            <a:prstGeom prst="straightConnector1">
              <a:avLst/>
            </a:prstGeom>
            <a:ln w="5724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9" name="Straight Arrow Connector 31"/>
            <p:cNvCxnSpPr/>
            <p:nvPr/>
          </p:nvCxnSpPr>
          <p:spPr>
            <a:xfrm>
              <a:off x="3094200" y="2284560"/>
              <a:ext cx="476640" cy="3600"/>
            </a:xfrm>
            <a:prstGeom prst="straightConnector1">
              <a:avLst/>
            </a:prstGeom>
            <a:ln w="5724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70" name="TextBox 32"/>
            <p:cNvSpPr/>
            <p:nvPr/>
          </p:nvSpPr>
          <p:spPr>
            <a:xfrm>
              <a:off x="6317640" y="2469600"/>
              <a:ext cx="1089720" cy="45900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Histological analysis 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71" name="Picture 33" descr=""/>
          <p:cNvPicPr/>
          <p:nvPr/>
        </p:nvPicPr>
        <p:blipFill>
          <a:blip r:embed="rId3"/>
          <a:stretch/>
        </p:blipFill>
        <p:spPr>
          <a:xfrm>
            <a:off x="257040" y="3606840"/>
            <a:ext cx="2928960" cy="3057480"/>
          </a:xfrm>
          <a:prstGeom prst="rect">
            <a:avLst/>
          </a:prstGeom>
          <a:ln w="0">
            <a:noFill/>
          </a:ln>
        </p:spPr>
      </p:pic>
      <p:pic>
        <p:nvPicPr>
          <p:cNvPr id="72" name="Picture 34" descr=""/>
          <p:cNvPicPr/>
          <p:nvPr/>
        </p:nvPicPr>
        <p:blipFill>
          <a:blip r:embed="rId4"/>
          <a:stretch/>
        </p:blipFill>
        <p:spPr>
          <a:xfrm>
            <a:off x="3143160" y="3535200"/>
            <a:ext cx="2862360" cy="3057840"/>
          </a:xfrm>
          <a:prstGeom prst="rect">
            <a:avLst/>
          </a:prstGeom>
          <a:ln w="0">
            <a:noFill/>
          </a:ln>
        </p:spPr>
      </p:pic>
      <p:sp>
        <p:nvSpPr>
          <p:cNvPr id="73" name="TextBox 35"/>
          <p:cNvSpPr/>
          <p:nvPr/>
        </p:nvSpPr>
        <p:spPr>
          <a:xfrm>
            <a:off x="334800" y="5519880"/>
            <a:ext cx="2938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Un-transfected cells (GFP negative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36"/>
          <p:cNvSpPr/>
          <p:nvPr/>
        </p:nvSpPr>
        <p:spPr>
          <a:xfrm>
            <a:off x="3219480" y="5564160"/>
            <a:ext cx="32702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ontrol px-485-fibroblasts(GFP positive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5" name="Picture 37" descr=""/>
          <p:cNvPicPr/>
          <p:nvPr/>
        </p:nvPicPr>
        <p:blipFill>
          <a:blip r:embed="rId5"/>
          <a:stretch/>
        </p:blipFill>
        <p:spPr>
          <a:xfrm>
            <a:off x="6235560" y="3606840"/>
            <a:ext cx="2657520" cy="3000240"/>
          </a:xfrm>
          <a:prstGeom prst="rect">
            <a:avLst/>
          </a:prstGeom>
          <a:ln w="0">
            <a:noFill/>
          </a:ln>
        </p:spPr>
      </p:pic>
      <p:sp>
        <p:nvSpPr>
          <p:cNvPr id="76" name="TextBox 38"/>
          <p:cNvSpPr/>
          <p:nvPr/>
        </p:nvSpPr>
        <p:spPr>
          <a:xfrm>
            <a:off x="6310440" y="5556240"/>
            <a:ext cx="2714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gBRCA1-fibroblasts (GFP positive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39"/>
          <p:cNvSpPr/>
          <p:nvPr/>
        </p:nvSpPr>
        <p:spPr>
          <a:xfrm>
            <a:off x="235080" y="3016080"/>
            <a:ext cx="5061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43"/>
          <p:cNvSpPr/>
          <p:nvPr/>
        </p:nvSpPr>
        <p:spPr>
          <a:xfrm>
            <a:off x="237960" y="217440"/>
            <a:ext cx="5065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44"/>
          <p:cNvSpPr/>
          <p:nvPr/>
        </p:nvSpPr>
        <p:spPr>
          <a:xfrm>
            <a:off x="372600" y="3311640"/>
            <a:ext cx="232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45"/>
          <p:cNvSpPr/>
          <p:nvPr/>
        </p:nvSpPr>
        <p:spPr>
          <a:xfrm>
            <a:off x="3157200" y="3289320"/>
            <a:ext cx="284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i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46"/>
          <p:cNvSpPr/>
          <p:nvPr/>
        </p:nvSpPr>
        <p:spPr>
          <a:xfrm>
            <a:off x="6291360" y="3311640"/>
            <a:ext cx="336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iii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82" name="Straight Arrow Connector 29"/>
          <p:cNvCxnSpPr/>
          <p:nvPr/>
        </p:nvCxnSpPr>
        <p:spPr>
          <a:xfrm flipV="1">
            <a:off x="4484160" y="1623600"/>
            <a:ext cx="445320" cy="596160"/>
          </a:xfrm>
          <a:prstGeom prst="straightConnector1">
            <a:avLst/>
          </a:prstGeom>
          <a:ln w="5724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83" name="Rectangle 5"/>
          <p:cNvSpPr/>
          <p:nvPr/>
        </p:nvSpPr>
        <p:spPr>
          <a:xfrm>
            <a:off x="5081760" y="1436760"/>
            <a:ext cx="2368440" cy="5202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In vitro population doubling analyse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60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1-25T22:20:47Z</dcterms:created>
  <dc:creator>Dana Hamam</dc:creator>
  <dc:description/>
  <dc:language>en-US</dc:language>
  <cp:lastModifiedBy>Si Mohamed</cp:lastModifiedBy>
  <dcterms:modified xsi:type="dcterms:W3CDTF">2016-02-03T22:30:48Z</dcterms:modified>
  <cp:revision>61</cp:revision>
  <dc:subject/>
  <dc:title>PowerPoint Presentation</dc:title>
</cp:coreProperties>
</file>